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5" r:id="rId3"/>
    <p:sldId id="256" r:id="rId4"/>
    <p:sldId id="257" r:id="rId5"/>
    <p:sldId id="280" r:id="rId6"/>
    <p:sldId id="258" r:id="rId7"/>
    <p:sldId id="259" r:id="rId8"/>
    <p:sldId id="276" r:id="rId9"/>
    <p:sldId id="260" r:id="rId10"/>
    <p:sldId id="261" r:id="rId11"/>
    <p:sldId id="279" r:id="rId12"/>
    <p:sldId id="278" r:id="rId13"/>
    <p:sldId id="271" r:id="rId14"/>
    <p:sldId id="272" r:id="rId15"/>
    <p:sldId id="274" r:id="rId16"/>
    <p:sldId id="262" r:id="rId17"/>
    <p:sldId id="263" r:id="rId18"/>
    <p:sldId id="264" r:id="rId19"/>
    <p:sldId id="265" r:id="rId20"/>
    <p:sldId id="266" r:id="rId21"/>
    <p:sldId id="267" r:id="rId22"/>
    <p:sldId id="268" r:id="rId2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07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ra Caffrey" initials="TC" lastIdx="1" clrIdx="0">
    <p:extLst/>
  </p:cmAuthor>
  <p:cmAuthor id="2" name="Tara" initials="T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27" autoAdjust="0"/>
    <p:restoredTop sz="94660"/>
  </p:normalViewPr>
  <p:slideViewPr>
    <p:cSldViewPr showGuides="1">
      <p:cViewPr>
        <p:scale>
          <a:sx n="128" d="100"/>
          <a:sy n="128" d="100"/>
        </p:scale>
        <p:origin x="546" y="-1986"/>
      </p:cViewPr>
      <p:guideLst>
        <p:guide orient="horz" pos="3120"/>
        <p:guide pos="2160"/>
        <p:guide orient="horz" pos="30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938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82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551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098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4221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7583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173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268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2634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7055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2826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6DAE91-4F02-429C-A4A2-5BBD3E8C05D8}" type="datetimeFigureOut">
              <a:rPr lang="en-GB" smtClean="0"/>
              <a:t>24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392D1-E18E-4B2E-B288-6721F8796E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5944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92696" y="704528"/>
            <a:ext cx="4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Material</a:t>
            </a:r>
          </a:p>
        </p:txBody>
      </p:sp>
      <p:sp>
        <p:nvSpPr>
          <p:cNvPr id="4" name="Rectangle 3"/>
          <p:cNvSpPr/>
          <p:nvPr/>
        </p:nvSpPr>
        <p:spPr>
          <a:xfrm>
            <a:off x="692696" y="1280592"/>
            <a:ext cx="5544616" cy="35291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/>
              <a:t>Haplotype-specific </a:t>
            </a:r>
            <a:r>
              <a:rPr lang="en-GB" b="1" i="1" dirty="0"/>
              <a:t>MAPT</a:t>
            </a:r>
            <a:r>
              <a:rPr lang="en-GB" b="1" dirty="0"/>
              <a:t> exon 3 expression regulated by common </a:t>
            </a:r>
            <a:r>
              <a:rPr lang="en-GB" b="1" dirty="0" err="1"/>
              <a:t>intronic</a:t>
            </a:r>
            <a:r>
              <a:rPr lang="en-GB" b="1" dirty="0"/>
              <a:t> polymorphisms associated with Parkinsonian disorders</a:t>
            </a:r>
          </a:p>
          <a:p>
            <a:pPr algn="just"/>
            <a:endParaRPr lang="en-GB" dirty="0"/>
          </a:p>
          <a:p>
            <a:pPr algn="just"/>
            <a:r>
              <a:rPr lang="en-GB" dirty="0"/>
              <a:t>Mang Ching Lai</a:t>
            </a:r>
            <a:r>
              <a:rPr lang="en-GB" baseline="30000" dirty="0"/>
              <a:t>1,2</a:t>
            </a:r>
            <a:r>
              <a:rPr lang="en-GB" dirty="0"/>
              <a:t>, Anne-Laure Bechy</a:t>
            </a:r>
            <a:r>
              <a:rPr lang="en-GB" baseline="30000" dirty="0"/>
              <a:t>1</a:t>
            </a:r>
            <a:r>
              <a:rPr lang="en-GB" dirty="0"/>
              <a:t>, Franziska Denk</a:t>
            </a:r>
            <a:r>
              <a:rPr lang="en-GB" baseline="30000" dirty="0"/>
              <a:t>1</a:t>
            </a:r>
            <a:r>
              <a:rPr lang="en-GB" dirty="0"/>
              <a:t>,</a:t>
            </a:r>
            <a:r>
              <a:rPr lang="en-GB" baseline="30000" dirty="0"/>
              <a:t> </a:t>
            </a:r>
            <a:r>
              <a:rPr lang="en-GB" dirty="0"/>
              <a:t>Emma Collins</a:t>
            </a:r>
            <a:r>
              <a:rPr lang="en-GB" baseline="30000" dirty="0"/>
              <a:t>1</a:t>
            </a:r>
            <a:r>
              <a:rPr lang="en-GB" dirty="0"/>
              <a:t>, Maria Gavriliouk</a:t>
            </a:r>
            <a:r>
              <a:rPr lang="en-GB" baseline="30000" dirty="0"/>
              <a:t>1</a:t>
            </a:r>
            <a:r>
              <a:rPr lang="en-GB" dirty="0"/>
              <a:t>, Judith B. Zaugg</a:t>
            </a:r>
            <a:r>
              <a:rPr lang="en-GB" baseline="30000" dirty="0"/>
              <a:t>2</a:t>
            </a:r>
            <a:r>
              <a:rPr lang="en-GB" dirty="0"/>
              <a:t>, Brent J. Ryan</a:t>
            </a:r>
            <a:r>
              <a:rPr lang="en-GB" baseline="30000" dirty="0"/>
              <a:t>1,3</a:t>
            </a:r>
            <a:r>
              <a:rPr lang="en-GB" dirty="0"/>
              <a:t> Richard Wade-Martins</a:t>
            </a:r>
            <a:r>
              <a:rPr lang="en-GB" baseline="30000" dirty="0"/>
              <a:t>1,3*, </a:t>
            </a:r>
            <a:r>
              <a:rPr lang="en-GB" dirty="0"/>
              <a:t>Tara M. Caffrey</a:t>
            </a:r>
            <a:r>
              <a:rPr lang="en-GB" baseline="30000" dirty="0"/>
              <a:t>1*</a:t>
            </a:r>
          </a:p>
          <a:p>
            <a:pPr algn="just"/>
            <a:endParaRPr lang="en-GB" dirty="0"/>
          </a:p>
          <a:p>
            <a:pPr algn="just"/>
            <a:r>
              <a:rPr lang="en-GB" sz="1400" baseline="30000" dirty="0"/>
              <a:t>1</a:t>
            </a:r>
            <a:r>
              <a:rPr lang="en-GB" sz="1400" dirty="0"/>
              <a:t>Department of Physiology, Anatomy and Genetics, University of Oxford, Oxford, OX1 3QX, UK</a:t>
            </a:r>
          </a:p>
          <a:p>
            <a:pPr algn="just"/>
            <a:r>
              <a:rPr lang="en-GB" sz="1400" baseline="30000" dirty="0"/>
              <a:t>2</a:t>
            </a:r>
            <a:r>
              <a:rPr lang="en-GB" sz="1400" dirty="0"/>
              <a:t>European Molecular Biology Laboratory, 69117 Heidelberg, Germany </a:t>
            </a:r>
          </a:p>
          <a:p>
            <a:pPr algn="just"/>
            <a:r>
              <a:rPr lang="en-GB" sz="1400" baseline="30000" dirty="0"/>
              <a:t>3</a:t>
            </a:r>
            <a:r>
              <a:rPr lang="en-GB" sz="1400" dirty="0"/>
              <a:t>Oxford Parkinson’s Disease Centre, University of Oxford, Oxford, OX1 3QX, UK</a:t>
            </a:r>
          </a:p>
          <a:p>
            <a:pPr algn="just"/>
            <a:endParaRPr lang="en-GB" sz="1400" baseline="30000" dirty="0"/>
          </a:p>
        </p:txBody>
      </p:sp>
    </p:spTree>
    <p:extLst>
      <p:ext uri="{BB962C8B-B14F-4D97-AF65-F5344CB8AC3E}">
        <p14:creationId xmlns:p14="http://schemas.microsoft.com/office/powerpoint/2010/main" val="36976603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533"/>
          <a:stretch/>
        </p:blipFill>
        <p:spPr>
          <a:xfrm>
            <a:off x="404664" y="272480"/>
            <a:ext cx="5518464" cy="800252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53437" y="7536610"/>
            <a:ext cx="516969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9. Endogenous MAPT expression in SK-N-F1 after candidate splice factor knockdown. </a:t>
            </a:r>
            <a:r>
              <a:rPr lang="en-GB" sz="1200" dirty="0"/>
              <a:t>A) </a:t>
            </a:r>
            <a:r>
              <a:rPr lang="en-GB" sz="1200" i="1" dirty="0"/>
              <a:t>MAPT </a:t>
            </a:r>
            <a:r>
              <a:rPr lang="en-GB" sz="1200" dirty="0"/>
              <a:t>exon 3 expression relative to total </a:t>
            </a:r>
            <a:r>
              <a:rPr lang="en-GB" sz="1200" i="1" dirty="0"/>
              <a:t>MAPT </a:t>
            </a:r>
            <a:r>
              <a:rPr lang="en-GB" sz="1200" dirty="0"/>
              <a:t>expression in SK-N-F1 cells treated with different siRNAs against splice factors  Any change in exon 3 expression will have take into account any changes in baseline MAPT expression due to splice factor silencing. B) Total </a:t>
            </a:r>
            <a:r>
              <a:rPr lang="en-GB" sz="1200" i="1" dirty="0"/>
              <a:t>MAPT </a:t>
            </a:r>
            <a:r>
              <a:rPr lang="en-GB" sz="1200" dirty="0"/>
              <a:t>expression relative to three endogenous control genes (</a:t>
            </a:r>
            <a:r>
              <a:rPr lang="en-GB" sz="1200" i="1" dirty="0"/>
              <a:t>GPADH</a:t>
            </a:r>
            <a:r>
              <a:rPr lang="en-GB" sz="1200" dirty="0"/>
              <a:t>, </a:t>
            </a:r>
            <a:r>
              <a:rPr lang="en-GB" sz="1200" i="1" dirty="0"/>
              <a:t>ACTB</a:t>
            </a:r>
            <a:r>
              <a:rPr lang="en-GB" sz="1200" dirty="0"/>
              <a:t>, </a:t>
            </a:r>
            <a:r>
              <a:rPr lang="en-GB" sz="1200" i="1" dirty="0"/>
              <a:t>HPRT1</a:t>
            </a:r>
            <a:r>
              <a:rPr lang="en-GB" sz="1200" dirty="0"/>
              <a:t>) in SK-N-F1 cells treated with different siRNAs against splice factors.   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2DC6B01-2AE4-4220-BF36-24F7332DD234}"/>
              </a:ext>
            </a:extLst>
          </p:cNvPr>
          <p:cNvSpPr txBox="1"/>
          <p:nvPr/>
        </p:nvSpPr>
        <p:spPr>
          <a:xfrm>
            <a:off x="1052736" y="4592960"/>
            <a:ext cx="482872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Figure S10. </a:t>
            </a:r>
            <a:r>
              <a:rPr lang="en-GB" sz="1100" b="1" dirty="0" err="1"/>
              <a:t>hnRNP</a:t>
            </a:r>
            <a:r>
              <a:rPr lang="en-GB" sz="1100" b="1" dirty="0"/>
              <a:t> Q and </a:t>
            </a:r>
            <a:r>
              <a:rPr lang="en-GB" sz="1100" b="1" dirty="0" err="1"/>
              <a:t>hnRNP</a:t>
            </a:r>
            <a:r>
              <a:rPr lang="en-GB" sz="1100" b="1" dirty="0"/>
              <a:t> F regulate the haplotype-specific inclusion of </a:t>
            </a:r>
            <a:r>
              <a:rPr lang="en-GB" sz="1100" b="1" i="1" dirty="0"/>
              <a:t>MAPT</a:t>
            </a:r>
            <a:r>
              <a:rPr lang="en-GB" sz="1100" b="1" dirty="0"/>
              <a:t> exon 3 in SK-N-MC neuroblastoma.</a:t>
            </a:r>
            <a:endParaRPr lang="en-GB" sz="1100" dirty="0"/>
          </a:p>
          <a:p>
            <a:r>
              <a:rPr lang="en-GB" sz="1100" dirty="0"/>
              <a:t>(A) Mean fold change in the normalised H1:H2 </a:t>
            </a:r>
            <a:r>
              <a:rPr lang="en-GB" sz="1100" i="1" dirty="0"/>
              <a:t>MAPT</a:t>
            </a:r>
            <a:r>
              <a:rPr lang="en-GB" sz="1100" dirty="0"/>
              <a:t> exon 3 transcript ratios in SK-N-F1 cells transfected with siRNA against </a:t>
            </a:r>
            <a:r>
              <a:rPr lang="en-GB" sz="1100" dirty="0" err="1"/>
              <a:t>hnRNP</a:t>
            </a:r>
            <a:r>
              <a:rPr lang="en-GB" sz="1100" dirty="0"/>
              <a:t> F and </a:t>
            </a:r>
            <a:r>
              <a:rPr lang="en-GB" sz="1100" dirty="0" err="1"/>
              <a:t>hnRNP</a:t>
            </a:r>
            <a:r>
              <a:rPr lang="en-GB" sz="1100" dirty="0"/>
              <a:t> Q (n=3), a negative siRNA control and a mock transfection (n=8). </a:t>
            </a:r>
            <a:r>
              <a:rPr lang="en-GB" sz="1100" dirty="0" err="1"/>
              <a:t>hnRNP</a:t>
            </a:r>
            <a:r>
              <a:rPr lang="en-GB" sz="1100" dirty="0"/>
              <a:t> F (1.74 ±-0.46, p &lt;0.05)  </a:t>
            </a:r>
            <a:r>
              <a:rPr lang="en-GB" sz="1100" dirty="0" err="1"/>
              <a:t>hnRNP</a:t>
            </a:r>
            <a:r>
              <a:rPr lang="en-GB" sz="1100" dirty="0"/>
              <a:t> Q (1.77 ±0.13, p &lt; 0.05). Statistical significance was determined by comparing each column to the mock control using one way ANOVA with Bonferroni correction. Error bars represent standard deviation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5F608D4-79C7-421F-86E5-F17097BEB2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6705" y="959109"/>
            <a:ext cx="4584589" cy="275563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DC05930-C65A-4F68-BBBD-709648206244}"/>
              </a:ext>
            </a:extLst>
          </p:cNvPr>
          <p:cNvSpPr txBox="1"/>
          <p:nvPr/>
        </p:nvSpPr>
        <p:spPr>
          <a:xfrm>
            <a:off x="2204864" y="106456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0D93271-A864-4143-98ED-8A22E6D6BDAB}"/>
              </a:ext>
            </a:extLst>
          </p:cNvPr>
          <p:cNvSpPr txBox="1"/>
          <p:nvPr/>
        </p:nvSpPr>
        <p:spPr>
          <a:xfrm>
            <a:off x="3117911" y="1046102"/>
            <a:ext cx="466201" cy="406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63645271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80A1388-3106-45A7-A933-0B314F69F9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257" y="1541612"/>
            <a:ext cx="3100855" cy="178997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4573AF6-EB8D-4FF4-8E32-5C92EB98DF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8091" y="1568624"/>
            <a:ext cx="3040447" cy="164595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E671C0F-0673-4225-AC78-72AA1EA2FC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7891" y="3592218"/>
            <a:ext cx="3600400" cy="27215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0A108E7-182E-4B92-8FC8-4050A1983391}"/>
              </a:ext>
            </a:extLst>
          </p:cNvPr>
          <p:cNvSpPr txBox="1"/>
          <p:nvPr/>
        </p:nvSpPr>
        <p:spPr>
          <a:xfrm>
            <a:off x="626359" y="6825208"/>
            <a:ext cx="56866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1. Splice factor protein expression in PSP patient and control frontal cortex. </a:t>
            </a:r>
            <a:r>
              <a:rPr lang="en-GB" sz="1200" dirty="0"/>
              <a:t>Western blots of (A) </a:t>
            </a:r>
            <a:r>
              <a:rPr lang="en-GB" sz="1200" dirty="0" err="1"/>
              <a:t>hnRNP</a:t>
            </a:r>
            <a:r>
              <a:rPr lang="en-GB" sz="1200" dirty="0"/>
              <a:t> F and (B) </a:t>
            </a:r>
            <a:r>
              <a:rPr lang="en-GB" sz="1200" dirty="0" err="1"/>
              <a:t>hnRNP</a:t>
            </a:r>
            <a:r>
              <a:rPr lang="en-GB" sz="1200" dirty="0"/>
              <a:t> Q from 5 PSP patients and 5 control post-mortem brain samples.  (C) Quantitation of western blots shows no significant differences in protein expression levels between PSP and controls for either </a:t>
            </a:r>
            <a:r>
              <a:rPr lang="en-GB" sz="1200" dirty="0" err="1"/>
              <a:t>hnRNP</a:t>
            </a:r>
            <a:r>
              <a:rPr lang="en-GB" sz="1200" dirty="0"/>
              <a:t> F and </a:t>
            </a:r>
            <a:r>
              <a:rPr lang="en-GB" sz="1200" dirty="0" err="1"/>
              <a:t>hnRNP</a:t>
            </a:r>
            <a:r>
              <a:rPr lang="en-GB" sz="1200" dirty="0"/>
              <a:t> Q though there is high variability between individuals for </a:t>
            </a:r>
            <a:r>
              <a:rPr lang="en-GB" sz="1200" dirty="0" err="1"/>
              <a:t>hnRNP</a:t>
            </a:r>
            <a:r>
              <a:rPr lang="en-GB" sz="1200" dirty="0"/>
              <a:t> F levels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8458A3-4D15-4A69-9BC8-5DFDF126036F}"/>
              </a:ext>
            </a:extLst>
          </p:cNvPr>
          <p:cNvSpPr txBox="1"/>
          <p:nvPr/>
        </p:nvSpPr>
        <p:spPr>
          <a:xfrm>
            <a:off x="260648" y="120858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6B714D-EC00-4C5B-9A95-CD7A04BD62E8}"/>
              </a:ext>
            </a:extLst>
          </p:cNvPr>
          <p:cNvSpPr txBox="1"/>
          <p:nvPr/>
        </p:nvSpPr>
        <p:spPr>
          <a:xfrm>
            <a:off x="3438158" y="119098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24E30E4-9C15-43F0-8550-30874002A7C0}"/>
              </a:ext>
            </a:extLst>
          </p:cNvPr>
          <p:cNvSpPr txBox="1"/>
          <p:nvPr/>
        </p:nvSpPr>
        <p:spPr>
          <a:xfrm>
            <a:off x="1239839" y="3592218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963147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5200" r="1504" b="5318"/>
          <a:stretch/>
        </p:blipFill>
        <p:spPr>
          <a:xfrm rot="5400000">
            <a:off x="-941517" y="1972885"/>
            <a:ext cx="9129466" cy="518369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0648" y="9129464"/>
            <a:ext cx="64807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2 </a:t>
            </a:r>
            <a:r>
              <a:rPr lang="en-GB" sz="1200" dirty="0"/>
              <a:t>Splice factor expression levels in various brain regions in </a:t>
            </a:r>
            <a:r>
              <a:rPr lang="en-GB" sz="1200" dirty="0" err="1"/>
              <a:t>GTEx</a:t>
            </a:r>
            <a:r>
              <a:rPr lang="en-GB" sz="1200" dirty="0"/>
              <a:t> donors. Gene levels are expressed as reads per kb per million mapped reads (</a:t>
            </a:r>
            <a:r>
              <a:rPr lang="en-GB" sz="1200" dirty="0" err="1"/>
              <a:t>rpkm</a:t>
            </a:r>
            <a:r>
              <a:rPr lang="en-GB" sz="1200" dirty="0"/>
              <a:t>). The dashed and dotted lines indicated </a:t>
            </a:r>
            <a:r>
              <a:rPr lang="en-GB" sz="1200" dirty="0" err="1"/>
              <a:t>rpkm</a:t>
            </a:r>
            <a:r>
              <a:rPr lang="en-GB" sz="1200" dirty="0"/>
              <a:t> values of 1 and 5, indicating gene expression above which as “expressed” and “moderately expressed”, respectively. </a:t>
            </a:r>
          </a:p>
        </p:txBody>
      </p:sp>
    </p:spTree>
    <p:extLst>
      <p:ext uri="{BB962C8B-B14F-4D97-AF65-F5344CB8AC3E}">
        <p14:creationId xmlns:p14="http://schemas.microsoft.com/office/powerpoint/2010/main" val="9133900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t="5200" b="5377"/>
          <a:stretch/>
        </p:blipFill>
        <p:spPr>
          <a:xfrm rot="5400000">
            <a:off x="-861738" y="912148"/>
            <a:ext cx="3993637" cy="2232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t="5319" b="5556"/>
          <a:stretch/>
        </p:blipFill>
        <p:spPr>
          <a:xfrm rot="5400000">
            <a:off x="3738542" y="913215"/>
            <a:ext cx="4006915" cy="2232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/>
          <a:srcRect t="5045" b="5473"/>
          <a:stretch/>
        </p:blipFill>
        <p:spPr>
          <a:xfrm rot="5400000">
            <a:off x="3701383" y="5029409"/>
            <a:ext cx="3990993" cy="2232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26720" y="8156267"/>
            <a:ext cx="64807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3 </a:t>
            </a:r>
            <a:r>
              <a:rPr lang="en-GB" sz="1200" dirty="0" err="1"/>
              <a:t>hnRNP</a:t>
            </a:r>
            <a:r>
              <a:rPr lang="en-GB" sz="1200" dirty="0"/>
              <a:t> F expression levels correlate poorly with MAPT exon 3+ and exon 3- transcripts in various brain regions in </a:t>
            </a:r>
            <a:r>
              <a:rPr lang="en-GB" sz="1200" dirty="0" err="1"/>
              <a:t>GTEx</a:t>
            </a:r>
            <a:r>
              <a:rPr lang="en-GB" sz="1200" dirty="0"/>
              <a:t> individuals.  Correlation value (r) was calculated by Pearson correlation. 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/>
          <a:srcRect t="5201" b="5626"/>
          <a:stretch/>
        </p:blipFill>
        <p:spPr>
          <a:xfrm rot="5400000">
            <a:off x="1462487" y="912149"/>
            <a:ext cx="4004785" cy="2232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6"/>
          <a:srcRect t="5263" b="5200"/>
          <a:stretch/>
        </p:blipFill>
        <p:spPr>
          <a:xfrm rot="5400000">
            <a:off x="-855236" y="5039171"/>
            <a:ext cx="3988519" cy="2232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7"/>
          <a:srcRect t="5200" b="5200"/>
          <a:stretch/>
        </p:blipFill>
        <p:spPr>
          <a:xfrm rot="5400000">
            <a:off x="1374224" y="5032048"/>
            <a:ext cx="3985713" cy="22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139399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5156" b="5511"/>
          <a:stretch/>
        </p:blipFill>
        <p:spPr>
          <a:xfrm rot="5400000">
            <a:off x="3743194" y="882806"/>
            <a:ext cx="3997612" cy="2232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5200" b="5200"/>
          <a:stretch/>
        </p:blipFill>
        <p:spPr>
          <a:xfrm rot="5400000">
            <a:off x="3739700" y="4971398"/>
            <a:ext cx="3985713" cy="2232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5200" b="5200"/>
          <a:stretch/>
        </p:blipFill>
        <p:spPr>
          <a:xfrm rot="5400000">
            <a:off x="1389016" y="4966733"/>
            <a:ext cx="3985713" cy="2232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5200" b="5436"/>
          <a:stretch/>
        </p:blipFill>
        <p:spPr>
          <a:xfrm rot="5400000">
            <a:off x="1383731" y="883469"/>
            <a:ext cx="3996285" cy="2232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t="5200" b="5318"/>
          <a:stretch/>
        </p:blipFill>
        <p:spPr>
          <a:xfrm rot="5400000">
            <a:off x="-879497" y="886221"/>
            <a:ext cx="3990993" cy="2232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t="5319" b="5319"/>
          <a:stretch/>
        </p:blipFill>
        <p:spPr>
          <a:xfrm rot="5400000">
            <a:off x="-882143" y="4972019"/>
            <a:ext cx="3996286" cy="2232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26720" y="8156267"/>
            <a:ext cx="64807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4 </a:t>
            </a:r>
            <a:r>
              <a:rPr lang="en-GB" sz="1200" dirty="0" err="1"/>
              <a:t>hnRNP</a:t>
            </a:r>
            <a:r>
              <a:rPr lang="en-GB" sz="1200" dirty="0"/>
              <a:t> Q expression levels correlate poorly with MAPT exon 3+ and exon 3- transcripts in various brain regions in </a:t>
            </a:r>
            <a:r>
              <a:rPr lang="en-GB" sz="1200" dirty="0" err="1"/>
              <a:t>GTEx</a:t>
            </a:r>
            <a:r>
              <a:rPr lang="en-GB" sz="1200" dirty="0"/>
              <a:t> individuals. Correlation value (r) was calculated by Pearson correlation. </a:t>
            </a:r>
          </a:p>
        </p:txBody>
      </p:sp>
    </p:spTree>
    <p:extLst>
      <p:ext uri="{BB962C8B-B14F-4D97-AF65-F5344CB8AC3E}">
        <p14:creationId xmlns:p14="http://schemas.microsoft.com/office/powerpoint/2010/main" val="14134248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5035224"/>
              </p:ext>
            </p:extLst>
          </p:nvPr>
        </p:nvGraphicFramePr>
        <p:xfrm>
          <a:off x="314494" y="348455"/>
          <a:ext cx="6129129" cy="8140781"/>
        </p:xfrm>
        <a:graphic>
          <a:graphicData uri="http://schemas.openxmlformats.org/drawingml/2006/table">
            <a:tbl>
              <a:tblPr firstRow="1" firstCol="1" bandRow="1"/>
              <a:tblGrid>
                <a:gridCol w="1473229">
                  <a:extLst>
                    <a:ext uri="{9D8B030D-6E8A-4147-A177-3AD203B41FA5}">
                      <a16:colId xmlns:a16="http://schemas.microsoft.com/office/drawing/2014/main" val="2114972253"/>
                    </a:ext>
                  </a:extLst>
                </a:gridCol>
                <a:gridCol w="4655900">
                  <a:extLst>
                    <a:ext uri="{9D8B030D-6E8A-4147-A177-3AD203B41FA5}">
                      <a16:colId xmlns:a16="http://schemas.microsoft.com/office/drawing/2014/main" val="2637590970"/>
                    </a:ext>
                  </a:extLst>
                </a:gridCol>
              </a:tblGrid>
              <a:tr h="2621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Primer name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Primer Sequence 5’ – 3’ 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2675373"/>
                  </a:ext>
                </a:extLst>
              </a:tr>
              <a:tr h="262128">
                <a:tc gridSpan="2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Primers for cloning pMAPT vector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06424"/>
                  </a:ext>
                </a:extLst>
              </a:tr>
              <a:tr h="415625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Segoe UI" panose="020B0502040204020203" pitchFamily="34" charset="0"/>
                        </a:rPr>
                        <a:t>pCYPAC2 25-mer R/ tau 5’ homology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Segoe UI" panose="020B0502040204020203" pitchFamily="34" charset="0"/>
                        </a:rPr>
                        <a:t>ttaagtgaaaatgtacagattgattattttcacctggtttctgttagattatcttAAAATCATTTAATTGGTGGTGCTGC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179312"/>
                  </a:ext>
                </a:extLst>
              </a:tr>
              <a:tr h="3683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Segoe UI" panose="020B0502040204020203" pitchFamily="34" charset="0"/>
                        </a:rPr>
                        <a:t>pCYPAC2 25-mer L/  tau 3’ homology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Segoe UI" panose="020B0502040204020203" pitchFamily="34" charset="0"/>
                        </a:rPr>
                        <a:t>agatagaaaatatcatacagctgacttcactagagagaaagtgcatcaactgcttATTGACCCGGAACCCTTAATATAAC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9031256"/>
                  </a:ext>
                </a:extLst>
              </a:tr>
              <a:tr h="262128">
                <a:tc gridSpan="2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Generating </a:t>
                      </a:r>
                      <a:r>
                        <a:rPr lang="en-GB" sz="10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pMAPT</a:t>
                      </a: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 with HA-tag sequence in exon 5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131127"/>
                  </a:ext>
                </a:extLst>
              </a:tr>
              <a:tr h="36017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Exon 5 + rpsl/chl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AACAGTGAAAATGGAGTGTGACAAGCATTCTTATTTTATATTTTATCAGCTCGCATGGTCAGTAAAAGCAAAGACGGCCTGGTGATGATGGCGGGATC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5835414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Exon 5 + rpsl/chl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CTGTAAACTTGACCAGCTGCAGAGCTCCGTGGCATCGTCAGCTTACCTTGGCTTTTTTGTCATCGCTTCCAGTCCCTTACGCCCCGCCCTGCCACTCA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988067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Ex5 HAtag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GAACAGTGAAAATGGAGTGTGACAAGCATTCTTATTTTATATTTTATCAGCTCGCATGGTCAGTAAAAGCAAAGACTACCCTTATGATGTTCCAGATT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6793182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Ex5 HAtag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CTGTAAACTTGACCAGCTGCAGAGCTCCGTGGCATCGTCAGCTTACCTTGGCTTTTTTGTCATCGCTTCCAGTCCCTGCGTAATCTGGAACATCATAA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3040885"/>
                  </a:ext>
                </a:extLst>
              </a:tr>
              <a:tr h="262128">
                <a:tc gridSpan="2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Generating </a:t>
                      </a:r>
                      <a:r>
                        <a:rPr lang="en-GB" sz="10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pMAPT</a:t>
                      </a:r>
                      <a:r>
                        <a:rPr lang="en-GB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 rs1800547 hybrid vectors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65116325"/>
                  </a:ext>
                </a:extLst>
              </a:tr>
              <a:tr h="33477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Ex3 + rpsl/chl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GCAGGCTGCCGCGCAGCCCCACACGGAGATCCCAGAAGGAACCACAGGT GAGGGTGGCCTGGTGATGATGGCGGGATC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1140083"/>
                  </a:ext>
                </a:extLst>
              </a:tr>
              <a:tr h="37465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Ex3 + rpsl/chl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TCACAGGTCAGCTGGGGCACCCAGCAGGGCCTTGACTGCCTGGGGGTCTC TGGGGCTTTACGCCCCGCCCTGCCACTCA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8720864"/>
                  </a:ext>
                </a:extLst>
              </a:tr>
              <a:tr h="2621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s1800547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CAGGGCTGCTTTCTGGC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7035088"/>
                  </a:ext>
                </a:extLst>
              </a:tr>
              <a:tr h="2621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s1800547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AAGCTCCCTCACTTCTG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025191"/>
                  </a:ext>
                </a:extLst>
              </a:tr>
              <a:tr h="262128">
                <a:tc gridSpan="2"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Generating pMAPT rs17651213 hybrid vector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6010395"/>
                  </a:ext>
                </a:extLst>
              </a:tr>
              <a:tr h="3629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Intron 3 + rpsl/chl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CCCCAGAGACCCCCAGGCAGTCAAGGCCCTGCTGGGTGCCCCAGCTGACCTGTGACAGAAGTGAGGGAGCTTTGGGCCTGGTGATGATGGCGGGAT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34966"/>
                  </a:ext>
                </a:extLst>
              </a:tr>
              <a:tr h="33655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Intron 3 + rpsl/chl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GGCATCGAGCTACTCACAACCCAAGATTCCCAGGAGCCAGAATCCACCCATGTTCCTGCCCCACAGGAGGATAAACTTACGCCCCGCCCTGCCACTCA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2516119"/>
                  </a:ext>
                </a:extLst>
              </a:tr>
              <a:tr h="2621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s17651213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CAGAGACCCCCAGGCAG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2948038"/>
                  </a:ext>
                </a:extLst>
              </a:tr>
              <a:tr h="2621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s17651213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CACCAAGGCATCGAGCTAC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3188893"/>
                  </a:ext>
                </a:extLst>
              </a:tr>
              <a:tr h="262128">
                <a:tc gridSpan="2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Generating pMAPT rs1800547 and rs17651213 hybrid vector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6855757"/>
                  </a:ext>
                </a:extLst>
              </a:tr>
              <a:tr h="32486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H1 Intron 3 + rpsl/chl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TGAGGGAGCTCCCGGCAAGCAGGCTGCCGCGCAGCCCCACACGGAGATCCCAGAAGGAACCACAGGTGAGGGTGAGCCCCAGAGACCCCCAGGCAGT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028193"/>
                  </a:ext>
                </a:extLst>
              </a:tr>
              <a:tr h="33655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H1 Intron 3 + rpsl/chl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GCAAGATGAGGAGCATCTAGAAGTCCAGAAGGCCCTAAATGCTCTGAGAGGCTGGCAGGCAGCCAGGGAGGTAACTGAGCACCAAGGCATCGAGCTA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1670586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H2 Intron 3 + rpsl/chl F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GATGAGGGAGCTCCCGGCAAGCAGGCTGCCGCGCAGCCCCACACGGAGATCCCAGAAGGAACCACAGGTGAGGGTAAGCCCCAGAGACCCCCAGGCAGT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924660"/>
                  </a:ext>
                </a:extLst>
              </a:tr>
              <a:tr h="3556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H2 Intron 3 + rpsl/chl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GGCAAGATGAGGAGCATCTAGAAGTCCAGAAGGCCCTAAATGCTCTGAGAGGCTGGCAGGCAGCCAGGGAGGTAACTGGGCACCAAGGCATCGAGCTA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5040739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s1800547 and rs17651213 F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TCAGGGCTGCTTTCTGG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956588"/>
                  </a:ext>
                </a:extLst>
              </a:tr>
              <a:tr h="31115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" panose="02020603050405020304" pitchFamily="18" charset="0"/>
                        </a:rPr>
                        <a:t>rs1800547 and rs17651213 R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ACCAAGGCATCGAGCT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322702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15416" y="8708449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able S1</a:t>
            </a:r>
            <a:r>
              <a:rPr lang="en-GB" sz="1200" dirty="0"/>
              <a:t>. Primer sequences for modifying pMAPT-H1WT and pMAPT-H2WT vectors. 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4141525"/>
              </p:ext>
            </p:extLst>
          </p:nvPr>
        </p:nvGraphicFramePr>
        <p:xfrm>
          <a:off x="1338178" y="458216"/>
          <a:ext cx="4128636" cy="7955280"/>
        </p:xfrm>
        <a:graphic>
          <a:graphicData uri="http://schemas.openxmlformats.org/drawingml/2006/table">
            <a:tbl>
              <a:tblPr firstRow="1" firstCol="1" bandRow="1"/>
              <a:tblGrid>
                <a:gridCol w="1363816">
                  <a:extLst>
                    <a:ext uri="{9D8B030D-6E8A-4147-A177-3AD203B41FA5}">
                      <a16:colId xmlns:a16="http://schemas.microsoft.com/office/drawing/2014/main" val="2321988079"/>
                    </a:ext>
                  </a:extLst>
                </a:gridCol>
                <a:gridCol w="2764820">
                  <a:extLst>
                    <a:ext uri="{9D8B030D-6E8A-4147-A177-3AD203B41FA5}">
                      <a16:colId xmlns:a16="http://schemas.microsoft.com/office/drawing/2014/main" val="2325839136"/>
                    </a:ext>
                  </a:extLst>
                </a:gridCol>
              </a:tblGrid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Primer Nam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Primer Sequence 5’ – 3’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1409127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ransgenic Total MAPT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AAGACGAAGCTGCTGGTC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3996361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ransgenic Total MAPT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CTTCCAGTCCCTGCGTAA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5283655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ransgenic MAPT Exon 3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AGAAGGAACCACAGCTGAAG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5311559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ransgenic MAPT Exon 3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GAACATCATAAGGGTAGTCTTTG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0484398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APDH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GTCTCCTCTGACTTCAAC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0461116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APDH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AGCCAAATTCGTTGTCATA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7682097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PRT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CCAGACTTTGTTGGATTT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9016772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PRT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CTCATCTTAGGCTTTGTATTTT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0696834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ACTB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AGCGCGGCTACAGCTTC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2020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ACTB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GTAGCACAGCTTCTCCTTAATG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0475623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F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ACTGCCAGGAGGTACATTG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5131835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F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GAGGTCTCTCCCGAACA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7996320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Q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GGGAAACTGGAACGAGTG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5409855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Q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ATCTGGTGGCTTGGCAAA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7444993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PTBP2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CGGTTCTTGTGAGCGAA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8628306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PTBP2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CAACCTCAGTGACGATTC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1568056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A2B1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GAGGTTGATGCTGCCAT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2243078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A2B1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ACAGCACGTTTTGGCTC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0183994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SFPQ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GGACTCGGAGGGGTTTAA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8252480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SFPQ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TTTTCTCTCCAGGCCTCC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4005004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ARDBP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GCTGGGGAAATCTGGTGT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8407299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ARDBP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657225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CGGATGTTTTCTGGACTG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6049015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M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CTTAATGGACGCTGAAGGAA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459561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M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GCTCAGACTATGCTTGTTTAG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8815261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ELAVL1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CGGGATAAAGTAGCAGGAC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229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ELAVL1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ATCGCTCTCTCTGCATCCT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494136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A0 F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CTCAATGTGCAGACGAGTG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1799825"/>
                  </a:ext>
                </a:extLst>
              </a:tr>
              <a:tr h="26675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nRNP A0 R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800100" algn="l"/>
                        </a:tabLst>
                      </a:pPr>
                      <a:r>
                        <a:rPr lang="en-GB" sz="9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AGTCCGTCAGAGTCCCAAAG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563" marR="5456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013618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38178" y="8662543"/>
            <a:ext cx="4468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able S2</a:t>
            </a:r>
            <a:r>
              <a:rPr lang="en-GB" sz="1200" dirty="0"/>
              <a:t>. Primer sequences for measuring gene expression 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5846035"/>
              </p:ext>
            </p:extLst>
          </p:nvPr>
        </p:nvGraphicFramePr>
        <p:xfrm>
          <a:off x="980728" y="1568624"/>
          <a:ext cx="5189220" cy="3017520"/>
        </p:xfrm>
        <a:graphic>
          <a:graphicData uri="http://schemas.openxmlformats.org/drawingml/2006/table">
            <a:tbl>
              <a:tblPr firstRow="1" firstCol="1" bandRow="1"/>
              <a:tblGrid>
                <a:gridCol w="1714160">
                  <a:extLst>
                    <a:ext uri="{9D8B030D-6E8A-4147-A177-3AD203B41FA5}">
                      <a16:colId xmlns:a16="http://schemas.microsoft.com/office/drawing/2014/main" val="387680006"/>
                    </a:ext>
                  </a:extLst>
                </a:gridCol>
                <a:gridCol w="3475060">
                  <a:extLst>
                    <a:ext uri="{9D8B030D-6E8A-4147-A177-3AD203B41FA5}">
                      <a16:colId xmlns:a16="http://schemas.microsoft.com/office/drawing/2014/main" val="2391875310"/>
                    </a:ext>
                  </a:extLst>
                </a:gridCol>
              </a:tblGrid>
              <a:tr h="29034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Primers/probes Nam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Sequence 5’ – 3’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3638115"/>
                  </a:ext>
                </a:extLst>
              </a:tr>
              <a:tr h="29034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Exon 3 F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CTCGCCTCTGTCGACTA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4378179"/>
                  </a:ext>
                </a:extLst>
              </a:tr>
              <a:tr h="29034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Exon 3 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TCACATCTTCCGCTGTTGG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6948101"/>
                  </a:ext>
                </a:extLst>
              </a:tr>
              <a:tr h="29034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enomic F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ACGTCCCAGCGTGATCT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7392683"/>
                  </a:ext>
                </a:extLst>
              </a:tr>
              <a:tr h="29034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Genomic 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CCCAACACTCCTCAGAAC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6120132"/>
                  </a:ext>
                </a:extLst>
              </a:tr>
              <a:tr h="627967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1 probe (FAM-NFQ MGB labelle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CTGGTTCAAAGTTC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4938034"/>
                  </a:ext>
                </a:extLst>
              </a:tr>
              <a:tr h="62363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H2 probe (VIC-NFQ MGB labelle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" panose="02020603050405020304" pitchFamily="18" charset="0"/>
                        </a:rPr>
                        <a:t>TGGTTCAAAGCTCAC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80440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80729" y="4819875"/>
            <a:ext cx="50254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able S3</a:t>
            </a:r>
            <a:r>
              <a:rPr lang="en-GB" sz="1200" dirty="0"/>
              <a:t>. Primers and probes sequence for the allele-specific qPCR assay to measure H1:H2 </a:t>
            </a:r>
            <a:r>
              <a:rPr lang="en-GB" sz="1200" i="1" dirty="0"/>
              <a:t>MAPT</a:t>
            </a:r>
            <a:r>
              <a:rPr lang="en-GB" sz="1200" dirty="0"/>
              <a:t> transcript ratios.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237412"/>
              </p:ext>
            </p:extLst>
          </p:nvPr>
        </p:nvGraphicFramePr>
        <p:xfrm>
          <a:off x="364809" y="1721487"/>
          <a:ext cx="5915025" cy="639224"/>
        </p:xfrm>
        <a:graphic>
          <a:graphicData uri="http://schemas.openxmlformats.org/drawingml/2006/table">
            <a:tbl>
              <a:tblPr/>
              <a:tblGrid>
                <a:gridCol w="532435">
                  <a:extLst>
                    <a:ext uri="{9D8B030D-6E8A-4147-A177-3AD203B41FA5}">
                      <a16:colId xmlns:a16="http://schemas.microsoft.com/office/drawing/2014/main" val="2989576144"/>
                    </a:ext>
                  </a:extLst>
                </a:gridCol>
                <a:gridCol w="3177974">
                  <a:extLst>
                    <a:ext uri="{9D8B030D-6E8A-4147-A177-3AD203B41FA5}">
                      <a16:colId xmlns:a16="http://schemas.microsoft.com/office/drawing/2014/main" val="3949490127"/>
                    </a:ext>
                  </a:extLst>
                </a:gridCol>
                <a:gridCol w="2204616">
                  <a:extLst>
                    <a:ext uri="{9D8B030D-6E8A-4147-A177-3AD203B41FA5}">
                      <a16:colId xmlns:a16="http://schemas.microsoft.com/office/drawing/2014/main" val="4289760565"/>
                    </a:ext>
                  </a:extLst>
                </a:gridCol>
              </a:tblGrid>
              <a:tr h="15980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eps</a:t>
                      </a:r>
                    </a:p>
                  </a:txBody>
                  <a:tcPr marL="6659" marR="6659" marT="665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lters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utcome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5063814"/>
                  </a:ext>
                </a:extLst>
              </a:tr>
              <a:tr h="15980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659" marR="6659" marT="665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ching proteins to 71 known splice factors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entify splice factors pulled-down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5133463"/>
                  </a:ext>
                </a:extLst>
              </a:tr>
              <a:tr h="15980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659" marR="6659" marT="665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entify inconsistent H1/H2 ratios 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iminate outlier in triplicates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5882737"/>
                  </a:ext>
                </a:extLst>
              </a:tr>
              <a:tr h="15980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659" marR="6659" marT="665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xclude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rotein if H1/H2 ratio lies between 0.8 - 1.2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dentify candidate splice factors</a:t>
                      </a:r>
                    </a:p>
                  </a:txBody>
                  <a:tcPr marL="6659" marR="6659" marT="665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14160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364809" y="2360712"/>
            <a:ext cx="59150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Table S4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</a:rPr>
              <a:t>. Mass spectrometry data analysis. Proteins identified by mass spectrometry were subjected to three steps for manually curating candidate splice factors</a:t>
            </a:r>
            <a:r>
              <a:rPr lang="en-GB" sz="1000" dirty="0">
                <a:solidFill>
                  <a:srgbClr val="000000"/>
                </a:solidFill>
                <a:latin typeface="Calibri" panose="020F050202020403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lh3.googleusercontent.com/I-PDICcZmKtDvJHeueFBWg37K_XmiZDie9zuJWKhwyfMJS603v1BwqNWlxVUz4lqjkVE0mdKRbmDNzPiccZaB4P3_DOwncJ8FQE0FnRJ747thfVrC0zRIUNi5E_wKRv6xxyrtSjz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3475" y="848544"/>
            <a:ext cx="5400675" cy="2028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28737" y="3440832"/>
            <a:ext cx="57606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1. </a:t>
            </a:r>
            <a:r>
              <a:rPr lang="en-GB" sz="1200" b="1" dirty="0" err="1"/>
              <a:t>Exongenous</a:t>
            </a:r>
            <a:r>
              <a:rPr lang="en-GB" sz="1200" b="1" dirty="0"/>
              <a:t> transgene MAPT expression assay. </a:t>
            </a:r>
            <a:r>
              <a:rPr lang="en-GB" sz="1200" dirty="0"/>
              <a:t>qPCR primer design for measuring MAPT exon 3 expression from the PAC MAPT genomic vectors. A </a:t>
            </a:r>
            <a:r>
              <a:rPr lang="en-GB" sz="1200" dirty="0" err="1"/>
              <a:t>haemagglutinnin</a:t>
            </a:r>
            <a:r>
              <a:rPr lang="en-GB" sz="1200" dirty="0"/>
              <a:t> tag (HA) was incorporated in frame in exon 5 to allow for transgenic to be distinguished from endogenous transcripts. </a:t>
            </a:r>
          </a:p>
        </p:txBody>
      </p:sp>
    </p:spTree>
    <p:extLst>
      <p:ext uri="{BB962C8B-B14F-4D97-AF65-F5344CB8AC3E}">
        <p14:creationId xmlns:p14="http://schemas.microsoft.com/office/powerpoint/2010/main" val="88220735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350601"/>
              </p:ext>
            </p:extLst>
          </p:nvPr>
        </p:nvGraphicFramePr>
        <p:xfrm>
          <a:off x="256744" y="151952"/>
          <a:ext cx="6209581" cy="8805672"/>
        </p:xfrm>
        <a:graphic>
          <a:graphicData uri="http://schemas.openxmlformats.org/drawingml/2006/table">
            <a:tbl>
              <a:tblPr firstRow="1" firstCol="1" bandRow="1"/>
              <a:tblGrid>
                <a:gridCol w="855704">
                  <a:extLst>
                    <a:ext uri="{9D8B030D-6E8A-4147-A177-3AD203B41FA5}">
                      <a16:colId xmlns:a16="http://schemas.microsoft.com/office/drawing/2014/main" val="871128564"/>
                    </a:ext>
                  </a:extLst>
                </a:gridCol>
                <a:gridCol w="5353877">
                  <a:extLst>
                    <a:ext uri="{9D8B030D-6E8A-4147-A177-3AD203B41FA5}">
                      <a16:colId xmlns:a16="http://schemas.microsoft.com/office/drawing/2014/main" val="703941117"/>
                    </a:ext>
                  </a:extLst>
                </a:gridCol>
              </a:tblGrid>
              <a:tr h="1558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ature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NP ID (</a:t>
                      </a:r>
                      <a:r>
                        <a:rPr lang="en-GB" sz="10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bSNP</a:t>
                      </a: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144)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63705"/>
                  </a:ext>
                </a:extLst>
              </a:tr>
              <a:tr h="97116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moter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7770150,rs17770186,rs17691449,rs62055544,rs62055545,rs62055546,rs62055547,rs62055548,rs113327263,rs62055549,rs62055550,rs62055551,rs62055552,rs62055553,rs62055554,rs62055555,rs111941646,rs62055556,rs62055557,rs62055558,rs62055559,rs79193046,rs17691466,rs7210728,rs17691508,rs62056760,rs55943606,rs55895732,rs55960528,rs55877243,rs17770296,rs17691556,rs62056761,rs62056773,rs62056774,rs62056775,rs62056776,rs78729125,rs17770343,rs62056777,rs17691610,rs76594404,rs80233201,rs62056778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424875"/>
                  </a:ext>
                </a:extLst>
              </a:tr>
              <a:tr h="8081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55780945,rs55711941,rs55709241,rs56280951,rs2664006,rs112206871,rs56166491,rs56226437,rs55907036,rs56294117,rs112415880,rs112003311,rs111751251,rs62063291,rs62063292,rs62063293,rs62063294,rs17650973,rs62063295,rs17650991,rs75145092,rs113857334,rs17572147,rs77513497,rs17572169,rs62063296,rs62641967,rs74373419,rs62063297,rs62063298,rs62063299,rs62063300,rs77566074,rs576159528,rs62063301,rs62063302,rs62063303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6973828"/>
                  </a:ext>
                </a:extLst>
              </a:tr>
              <a:tr h="68416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-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1575896,rs74457229,rs3744457,rs74548327,rs111972148,rs76324150,rs113347741,rs78720789,rs4792891,rs62056780,rs62056781,rs74496580,rs62056782,rs113161176,rs80346216,rs76632685,rs62056783,rs62056784,rs62056785,rs62056786,rs62056789,rs62056790,rs62056791,rs11079726,rs77561671,rs62056792,rs9303523,rs62056793,rs62056794,rs1864324,rs1864325,rs28646281,rs62056795,rs62056796,rs55691306,rs56306380,rs55841786,rs55823844,rs1560310,rs1467962,rs1560311,rs1467963,rs1560312,rs62056800,rs62056801,rs113834264,rs2099151,rs2082068,rs930119,rs1984937,rs62056802,rs112003140,rs111689007,rs113589236,rs113029914,rs112275277,rs367820416,rs62056803,rs62056804,rs77084869,rs74573628,rs75617973,rs62056805,rs62056806,rs62056807,rs1467966,rs62056808,rs62056809,rs62056810,rs79492906,rs62056811,rs74509629,rs79290980,rs1467967,rs1467968,rs4371195,rs12150125,rs12150527,rs7502888,rs62056812,rs111447859,rs28439143,rs56189701,rs62056835,rs62056837,rs62056838,rs62056839,rs62056840,rs112116311,rs78209533,rs62056841,rs79860128,rs9944484,rs17563965,rs17563986,rs17564020,rs55682376,rs55788678,rs56042957,rs55810795,rs55933304,rs62056848,rs62056849,rs62056850,rs62056851,rs62056856,rs9899833,rs77926909,rs111541901,rs17649518,rs62056859,rs112647192,rs17649553,rs17649571,rs17564153,rs17649635,rs8080903,rs1560313,rs113271363,rs55760800,rs56303672,rs17649641,rs75046472,rs17564223,rs17649700,rs62058962,rs1467969,rs1467970,rs767058,rs767057,rs767056,rs767059,rs62058964,rs62058965,rs1967981,rs1476127,rs55929431,rs8079501,rs56002706,rs8078495,rs17649866,rs62058968,rs17564493,rs17649918,rs17649954,rs55685451,rs17564591,rs17564619,rs9904290,rs9901881,rs62059003,rs17650063,rs17564703,rs2055797,rs76090253,rs55788597,rs56197117,rs371618052,rs56249311,rs62059004,rs76500077,rs62059005,rs113313477,rs112439933,rs113796169,rs112454267,rs112166495,rs17564780,rs62059007,rs1001945,rs62059008,rs62059009,rs1967982,rs62061705,rs17564829,rs62061706,rs62061707,rs62061708,rs62061709,rs62061710,rs62061711,rs113912415,rs8078967,rs57389672,rs62061712,rs7501759,rs2316782,rs2316783,rs4255816,rs62061713,rs8065800,rs113952577,rs78077519,rs17564871,rs17650258,rs62061715,rs17564948,rs17564983,rs62061716,rs62061717,rs62061718,rs17650335,rs17565025,rs77924424,rs62061719,rs17650381,rs17650417,rs62061720,rs62061721,rs79857651,rs113756354,rs12150111,rs56072903,rs12150460,rs12150195,rs55874169,rs62061723,rs62061724,rs12150229,rs12150230,rs12150576,rs12150235,rs12150242,rs12150104,rs62061725,rs62061726,rs113537106,rs62061727,rs62061728,rs62061729,rs62061730,rs62061731,rs62061732,rs62061733,rs62061734,rs7210219,rs62062768,rs62062769,rs62062770,rs242557,rs62062771,rs62062772,rs62062773,rs79115768,rs28416808,rs62062774,rs2316784,rs4327091,rs4479290,rs62062776,rs62062777,rs75839508,rs75686108,rs79765413,rs78834738,rs62062778,rs62062779,rs62062780,rs62062781,rs62062782,rs62062783,rs35163442,rs62062784,rs62062785,rs62062786,rs62062787,rs62062788,rs62062789,rs62062790,rs62062791,rs62062792,rs78026984,rs113395365,rs242559,rs62062793,rs62062794,rs78556223,rs77266933,rs74531363,rs242561,rs242562,rs62062795,rs62062796,rs62062797,rs62062798,rs62062799,rs62062800,rs62062801,rs62062802,rs62062803,rs74903707,rs77017444,rs76839282,rs17650579,rs17650597,rs17650633,rs17650651,rs62062805,rs62062806,rs55978005,rs55946323,rs56317731,rs55821155,rs56080482,rs17571718,rs78555354,rs62062813,rs62063262,rs113520245,rs113277432,rs112950348,rs62063263,rs62063264,rs62063265,rs62063266,rs17571781,rs56201245,rs55746658,rs56367860,rs62063269,rs17571809,rs80190331,rs17650771,rs77555455,rs17571857,rs62063271,rs62063275,rs62063276,rs62063277,rs17650818,rs62063278,rs62063279,rs113793114,rs62063280,rs17650842,rs62063281,rs17650860,rs62063282,rs242554,rs111520035,rs17650872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4135462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4447" y="8985448"/>
            <a:ext cx="652910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Table S5</a:t>
            </a:r>
            <a:r>
              <a:rPr lang="en-GB" sz="1200" dirty="0"/>
              <a:t>. SNPs captured by the pMAPT-H1 and pMAPT-H2 vectors . SNP data from the </a:t>
            </a:r>
            <a:r>
              <a:rPr lang="en-GB" sz="1200" dirty="0" err="1"/>
              <a:t>dbSNP</a:t>
            </a:r>
            <a:r>
              <a:rPr lang="en-GB" sz="1200" dirty="0"/>
              <a:t> database in the 143 kb </a:t>
            </a:r>
            <a:r>
              <a:rPr lang="en-GB" sz="1200" i="1" dirty="0"/>
              <a:t>MAPT </a:t>
            </a:r>
            <a:r>
              <a:rPr lang="en-GB" sz="1200" dirty="0"/>
              <a:t>region covered by our H1/H2 BAC/PAC vectors were used for comparisons between H1 and H2 sequences. SNPs with a minor allele frequency of ≥5% as catalogued in the 1000 Genomes Project were included</a:t>
            </a:r>
            <a:r>
              <a:rPr lang="en-GB" sz="10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776469"/>
              </p:ext>
            </p:extLst>
          </p:nvPr>
        </p:nvGraphicFramePr>
        <p:xfrm>
          <a:off x="283248" y="793197"/>
          <a:ext cx="6209581" cy="6589050"/>
        </p:xfrm>
        <a:graphic>
          <a:graphicData uri="http://schemas.openxmlformats.org/drawingml/2006/table">
            <a:tbl>
              <a:tblPr firstRow="1" firstCol="1" bandRow="1"/>
              <a:tblGrid>
                <a:gridCol w="855704">
                  <a:extLst>
                    <a:ext uri="{9D8B030D-6E8A-4147-A177-3AD203B41FA5}">
                      <a16:colId xmlns:a16="http://schemas.microsoft.com/office/drawing/2014/main" val="540032072"/>
                    </a:ext>
                  </a:extLst>
                </a:gridCol>
                <a:gridCol w="5353877">
                  <a:extLst>
                    <a:ext uri="{9D8B030D-6E8A-4147-A177-3AD203B41FA5}">
                      <a16:colId xmlns:a16="http://schemas.microsoft.com/office/drawing/2014/main" val="2734078678"/>
                    </a:ext>
                  </a:extLst>
                </a:gridCol>
              </a:tblGrid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2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75242405,rs17651093,rs17572248,rs62063304,rs62063305,rs17651134,rs62063306,rs62063774,rs62063775,rs9896485,rs62063776,rs10514889,rs117124984,rs118087478,rs77875796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474221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3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800547,rs17651213,rs17572361,rs17651243,rs78104015,rs62063777,rs2217394,rs62063778,rs17651285,rs17572467,rs17572495,rs62063779,rs754593,rs754513,rs754512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517055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4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3780,rs2163129,rs2163130,rs1981997,rs1981998,rs3785884,rs17572613,rs77527347,rs2435206,rs17572627,rs62063781,rs62063782,rs17651483,rs2435207,rs62063783,rs62063784,rs56234850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483032"/>
                  </a:ext>
                </a:extLst>
              </a:tr>
              <a:tr h="15582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4A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2435209,rs2435210,rs6503453,rs243521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4221052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5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713522,rs10445371,rs919461,rs919462,rs919464,rs62063794,rs112385572,rs17651700,rs372810927,rs111240522,rs113134013,rs76357066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0093523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6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79447161,rs17651754,rs10445338,rs111652694,rs75743061,rs62063795,rs62063796,rs62063797,rs2435214,rs77290642,rs76618565,rs62063798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1459219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7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3799,rs62063800,rs62063801,rs17651857,rs74759276,rs17651887,rs78599197,rs62063842,rs55662347,rs2471737,rs55913645,rs17573175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438083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8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3846,rs2435200,rs55736025,rs55886080,rs75944932,rs17573245,rs17573266,rs112572874,rs17652036,rs62063849,rs17652066,rs62063850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7984915"/>
                  </a:ext>
                </a:extLst>
              </a:tr>
              <a:tr h="97116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9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3851,rs62063852,rs62063853,rs62063854,rs2004673,rs2004674,rs62063855,rs1078269,rs1078268,rs62063856,rs62063857,rs79959255,rs56301633,rs56108300,rs62063859,rs571326569,rs62064660,rs62064661,rs17573447,rs62064662,rs62064663,rs2471739,rs113894932,rs2435202,rs8070723,rs17573509,rs62064664,rs62064665,rs111324579,rs113201171,rs112310745,rs74450848,rs74846646,rs62064666,rs62064667,rs17573593,rs62064668,rs17573607,rs2435203,rs17652337,rs1991556,rs112836774,rs113316734,rs74829364,rs78962882,rs78136862,rs62064670,rs62064671,rs62064672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1251975"/>
                  </a:ext>
                </a:extLst>
              </a:tr>
              <a:tr h="4819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10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4674,rs62064675,rs17652449,rs76723223,rs733966,rs733967,rs733968,rs733969,rs4283261,rs62062265,rs75666751,rs4306559,rs747152,rs12150254,rs12150170,rs12150515,rs62062266,rs41543512,rs60969130,rs17573858,rs62062267,rs62062268,rs62062269,rs62062270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7242827"/>
                  </a:ext>
                </a:extLst>
              </a:tr>
              <a:tr h="4819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1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75534191,rs9891103,rs62062271,rs62062272,rs62062273,rs12150469,rs12149995,rs62062274,rs62062275,rs62062276,rs62062277,rs62062278,rs62062279,rs62062280,rs62062281,rs62062282,rs17652502,rs2316948,rs9709338,rs62062283,rs111976319,rs58879558,rs62062284,rs62062285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0906432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tron 12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2286,rs62062287,rs62062288,rs62062289,rs17652520,rs17573907,rs62062290,rs55726761,rs62062292,rs77747656,rs62062293,rs62062294,rs62062295,rs62062296,rs62062297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4203606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13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9468,rs8712,rs1052587,rs1052590,rs1052594,rs17574040,rs16940799,rs7687,rs17652748,rs75010486,rs16940806,rs2158257,rs17574228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9275123"/>
                  </a:ext>
                </a:extLst>
              </a:tr>
              <a:tr h="3188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'UTR &amp; downstream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78681971,rs79772576,rs78229689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9232774"/>
                  </a:ext>
                </a:extLst>
              </a:tr>
              <a:tr h="201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-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1575895,rs62056779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1668070"/>
                  </a:ext>
                </a:extLst>
              </a:tr>
              <a:tr h="201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765090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6184628"/>
                  </a:ext>
                </a:extLst>
              </a:tr>
              <a:tr h="201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6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2258689,rs10445337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077514"/>
                  </a:ext>
                </a:extLst>
              </a:tr>
              <a:tr h="201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7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05255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0242697"/>
                  </a:ext>
                </a:extLst>
              </a:tr>
              <a:tr h="201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8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62063845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81756"/>
                  </a:ext>
                </a:extLst>
              </a:tr>
              <a:tr h="201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on 9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s1052553,rs17652121</a:t>
                      </a:r>
                    </a:p>
                  </a:txBody>
                  <a:tcPr marL="14071" marR="1407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652808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0648" y="7401272"/>
            <a:ext cx="62646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Table S5</a:t>
            </a:r>
            <a:r>
              <a:rPr lang="en-GB" sz="1200" dirty="0"/>
              <a:t>. SNPs captured by the pMAPT-H1 and pMAPT-H2 vectors . SNP data from the </a:t>
            </a:r>
            <a:r>
              <a:rPr lang="en-GB" sz="1200" dirty="0" err="1"/>
              <a:t>dbSNP</a:t>
            </a:r>
            <a:r>
              <a:rPr lang="en-GB" sz="1200" dirty="0"/>
              <a:t> database in the 143 kb </a:t>
            </a:r>
            <a:r>
              <a:rPr lang="en-GB" sz="1200" i="1" dirty="0"/>
              <a:t>MAPT </a:t>
            </a:r>
            <a:r>
              <a:rPr lang="en-GB" sz="1200" dirty="0"/>
              <a:t>region covered by our H1/H2 BAC/PAC vectors were used for comparisons between H1 and H2 sequences. SNPs with a minor allele frequency of ≥5% as catalogued in the 1000 Genomes Project were included.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0465282"/>
              </p:ext>
            </p:extLst>
          </p:nvPr>
        </p:nvGraphicFramePr>
        <p:xfrm>
          <a:off x="134231" y="881953"/>
          <a:ext cx="6319909" cy="3108960"/>
        </p:xfrm>
        <a:graphic>
          <a:graphicData uri="http://schemas.openxmlformats.org/drawingml/2006/table">
            <a:tbl>
              <a:tblPr/>
              <a:tblGrid>
                <a:gridCol w="2148352">
                  <a:extLst>
                    <a:ext uri="{9D8B030D-6E8A-4147-A177-3AD203B41FA5}">
                      <a16:colId xmlns:a16="http://schemas.microsoft.com/office/drawing/2014/main" val="1983532409"/>
                    </a:ext>
                  </a:extLst>
                </a:gridCol>
                <a:gridCol w="2419502">
                  <a:extLst>
                    <a:ext uri="{9D8B030D-6E8A-4147-A177-3AD203B41FA5}">
                      <a16:colId xmlns:a16="http://schemas.microsoft.com/office/drawing/2014/main" val="2002111617"/>
                    </a:ext>
                  </a:extLst>
                </a:gridCol>
                <a:gridCol w="1752055">
                  <a:extLst>
                    <a:ext uri="{9D8B030D-6E8A-4147-A177-3AD203B41FA5}">
                      <a16:colId xmlns:a16="http://schemas.microsoft.com/office/drawing/2014/main" val="2278413071"/>
                    </a:ext>
                  </a:extLst>
                </a:gridCol>
              </a:tblGrid>
              <a:tr h="182880">
                <a:tc gridSpan="3">
                  <a:txBody>
                    <a:bodyPr/>
                    <a:lstStyle/>
                    <a:p>
                      <a:pPr algn="l" fontAlgn="ctr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415999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Symbo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e Count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±S.D.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810958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HDRBS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205994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AVL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55829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BP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94543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MX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233115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K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543625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U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536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A2B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744683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BP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806313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HDRBS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34483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PQ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12634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84475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RSF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6363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3B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195068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 Q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940228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BP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8194808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1029460"/>
              </p:ext>
            </p:extLst>
          </p:nvPr>
        </p:nvGraphicFramePr>
        <p:xfrm>
          <a:off x="134228" y="4567714"/>
          <a:ext cx="6319910" cy="2560320"/>
        </p:xfrm>
        <a:graphic>
          <a:graphicData uri="http://schemas.openxmlformats.org/drawingml/2006/table">
            <a:tbl>
              <a:tblPr/>
              <a:tblGrid>
                <a:gridCol w="2377787">
                  <a:extLst>
                    <a:ext uri="{9D8B030D-6E8A-4147-A177-3AD203B41FA5}">
                      <a16:colId xmlns:a16="http://schemas.microsoft.com/office/drawing/2014/main" val="3631567157"/>
                    </a:ext>
                  </a:extLst>
                </a:gridCol>
                <a:gridCol w="2544651">
                  <a:extLst>
                    <a:ext uri="{9D8B030D-6E8A-4147-A177-3AD203B41FA5}">
                      <a16:colId xmlns:a16="http://schemas.microsoft.com/office/drawing/2014/main" val="1316743337"/>
                    </a:ext>
                  </a:extLst>
                </a:gridCol>
                <a:gridCol w="1397472">
                  <a:extLst>
                    <a:ext uri="{9D8B030D-6E8A-4147-A177-3AD203B41FA5}">
                      <a16:colId xmlns:a16="http://schemas.microsoft.com/office/drawing/2014/main" val="3694279198"/>
                    </a:ext>
                  </a:extLst>
                </a:gridCol>
              </a:tblGrid>
              <a:tr h="182880">
                <a:tc gridSpan="3"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08604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 Symbo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ptide Count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±S.D.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59429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PQ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47033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DBP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34235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M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63321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AVL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40367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H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38034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A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40601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BP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56375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 Q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012331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A2B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13769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BP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605084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HDRBS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376054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NRNPF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466050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739140" y="3990914"/>
            <a:ext cx="54483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GB" sz="1000" b="1" dirty="0">
                <a:solidFill>
                  <a:srgbClr val="000000"/>
                </a:solidFill>
                <a:latin typeface="Calibri" panose="020F0502020204030204" pitchFamily="34" charset="0"/>
              </a:rPr>
              <a:t>Table S6. </a:t>
            </a:r>
            <a:r>
              <a:rPr lang="en-GB" sz="1000" dirty="0">
                <a:solidFill>
                  <a:srgbClr val="000000"/>
                </a:solidFill>
                <a:latin typeface="Calibri" panose="020F0502020204030204" pitchFamily="34" charset="0"/>
              </a:rPr>
              <a:t>Peptide counts for protein quantification in rs1800547 M.S. analysis</a:t>
            </a:r>
          </a:p>
        </p:txBody>
      </p:sp>
      <p:sp>
        <p:nvSpPr>
          <p:cNvPr id="5" name="Rectangle 4"/>
          <p:cNvSpPr/>
          <p:nvPr/>
        </p:nvSpPr>
        <p:spPr>
          <a:xfrm>
            <a:off x="739140" y="7099874"/>
            <a:ext cx="571499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685800" fontAlgn="ctr">
              <a:defRPr/>
            </a:pPr>
            <a:r>
              <a:rPr lang="en-GB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Table S7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</a:rPr>
              <a:t>. Peptide counts for protein quantification in rs17651213 M.S. analysis</a:t>
            </a:r>
          </a:p>
        </p:txBody>
      </p:sp>
    </p:spTree>
    <p:extLst>
      <p:ext uri="{BB962C8B-B14F-4D97-AF65-F5344CB8AC3E}">
        <p14:creationId xmlns:p14="http://schemas.microsoft.com/office/powerpoint/2010/main" val="4039235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7430" y="7485138"/>
            <a:ext cx="551190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2. rs1800547 and rs17651213 are in linkage disequilibrium with the H1/H2 haplotype structure.  </a:t>
            </a:r>
            <a:r>
              <a:rPr lang="en-GB" sz="1200" dirty="0"/>
              <a:t>Linkage analysis performed using CEU population genotype data from the international </a:t>
            </a:r>
            <a:r>
              <a:rPr lang="en-GB" sz="1200" dirty="0" err="1"/>
              <a:t>HapMap</a:t>
            </a:r>
            <a:r>
              <a:rPr lang="en-GB" sz="1200" dirty="0"/>
              <a:t> project by the programme </a:t>
            </a:r>
            <a:r>
              <a:rPr lang="en-GB" sz="1200" dirty="0" err="1"/>
              <a:t>Haploview</a:t>
            </a:r>
            <a:r>
              <a:rPr lang="en-GB" sz="1200" dirty="0"/>
              <a:t>. The linkage disequilibrium plot shows rs1800547 and rs17651213 are in linkage disequilibrium with the H1/H2 haplotype structure as represented by haplotype tagging SNPs. Genomic coordinates on the top. </a:t>
            </a:r>
            <a:r>
              <a:rPr lang="en-GB" sz="1200" dirty="0" err="1"/>
              <a:t>gt’d</a:t>
            </a:r>
            <a:r>
              <a:rPr lang="en-GB" sz="1200" dirty="0"/>
              <a:t> SNPs/20kb: genotyped SNPs per 20 kb region. Gene names and transcripts are indicated above the linkage disequilibrium plot. </a:t>
            </a:r>
          </a:p>
        </p:txBody>
      </p:sp>
      <p:pic>
        <p:nvPicPr>
          <p:cNvPr id="5" name="Picture 4" descr="L:\Wade-Martins Group\Members\Brian\Thesis\Figures\LD simon-sanchez.tif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446"/>
          <a:stretch/>
        </p:blipFill>
        <p:spPr bwMode="auto">
          <a:xfrm>
            <a:off x="728662" y="992560"/>
            <a:ext cx="5400675" cy="618172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3346429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L:\Wade-Martins Group\Members\Brian\2015\For paper\transfection efficiencies LZW.ti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325" y="1712640"/>
            <a:ext cx="5975350" cy="4678681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665018" y="6114323"/>
            <a:ext cx="55767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3. Assessing transfection efficiencies by </a:t>
            </a:r>
            <a:r>
              <a:rPr lang="en-GB" sz="1200" b="1" dirty="0" err="1"/>
              <a:t>lacZ</a:t>
            </a:r>
            <a:r>
              <a:rPr lang="en-GB" sz="1200" b="1" dirty="0"/>
              <a:t> expression</a:t>
            </a:r>
            <a:r>
              <a:rPr lang="en-GB" sz="1200" dirty="0"/>
              <a:t>. Cells expressing pMAPT-H1WT and pMAPT-H2WT vectors are visualised in blue. pH-FRT-HY plasmid containing the </a:t>
            </a:r>
            <a:r>
              <a:rPr lang="en-GB" sz="1200" dirty="0" err="1"/>
              <a:t>lacZ</a:t>
            </a:r>
            <a:r>
              <a:rPr lang="en-GB" sz="1200" dirty="0"/>
              <a:t> gene without the </a:t>
            </a:r>
            <a:r>
              <a:rPr lang="en-GB" sz="1200" i="1" dirty="0"/>
              <a:t>MAPT </a:t>
            </a:r>
            <a:r>
              <a:rPr lang="en-GB" sz="1200" dirty="0"/>
              <a:t>gene was used as a positive control for </a:t>
            </a:r>
            <a:r>
              <a:rPr lang="en-GB" sz="1200" dirty="0" err="1"/>
              <a:t>lacZ</a:t>
            </a:r>
            <a:r>
              <a:rPr lang="en-GB" sz="1200" dirty="0"/>
              <a:t> expression. </a:t>
            </a:r>
          </a:p>
        </p:txBody>
      </p:sp>
    </p:spTree>
    <p:extLst>
      <p:ext uri="{BB962C8B-B14F-4D97-AF65-F5344CB8AC3E}">
        <p14:creationId xmlns:p14="http://schemas.microsoft.com/office/powerpoint/2010/main" val="1378112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9110" r="19037" b="815"/>
          <a:stretch/>
        </p:blipFill>
        <p:spPr>
          <a:xfrm>
            <a:off x="1440354" y="4448906"/>
            <a:ext cx="4454880" cy="446488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8963" t="-1" r="18889" b="697"/>
          <a:stretch/>
        </p:blipFill>
        <p:spPr>
          <a:xfrm>
            <a:off x="1440354" y="1"/>
            <a:ext cx="4454880" cy="44489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0649" y="8901813"/>
            <a:ext cx="64807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4 H1 and H2 MAPT a) exon 3+ and b) exon 3-  transcript expression in various brain regions in </a:t>
            </a:r>
            <a:r>
              <a:rPr lang="en-GB" sz="1200" b="1" dirty="0" err="1"/>
              <a:t>GTEx</a:t>
            </a:r>
            <a:r>
              <a:rPr lang="en-GB" sz="1200" b="1" dirty="0"/>
              <a:t> donors</a:t>
            </a:r>
            <a:r>
              <a:rPr lang="en-GB" sz="1200" dirty="0"/>
              <a:t>. Transcript levels are expressed as reads per kb per million mapped reads (</a:t>
            </a:r>
            <a:r>
              <a:rPr lang="en-GB" sz="1200" dirty="0" err="1"/>
              <a:t>rpkm</a:t>
            </a:r>
            <a:r>
              <a:rPr lang="en-GB" sz="1200" dirty="0"/>
              <a:t>). P-adjusted values (</a:t>
            </a:r>
            <a:r>
              <a:rPr lang="en-GB" sz="1200" dirty="0" err="1"/>
              <a:t>p.adj</a:t>
            </a:r>
            <a:r>
              <a:rPr lang="en-GB" sz="1200" dirty="0"/>
              <a:t>) were obtained using paired t-tests followed by </a:t>
            </a:r>
            <a:r>
              <a:rPr lang="en-GB" sz="1200" dirty="0" err="1"/>
              <a:t>Benjamini</a:t>
            </a:r>
            <a:r>
              <a:rPr lang="en-GB" sz="1200" dirty="0"/>
              <a:t> &amp; Hochberg correction. The number of individuals per haplotype (n) is indicated on the plot. H1 </a:t>
            </a:r>
            <a:r>
              <a:rPr lang="en-GB" sz="1200" dirty="0" err="1"/>
              <a:t>indictaes</a:t>
            </a:r>
            <a:r>
              <a:rPr lang="en-GB" sz="1200" dirty="0"/>
              <a:t> H1/H1 homozygotes and H2 indicates individuals with at least one H2 allele (H1/H2 or H2/H2)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65920" y="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165920" y="4448905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360423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36" t="33607" r="15002" b="52292"/>
          <a:stretch/>
        </p:blipFill>
        <p:spPr>
          <a:xfrm>
            <a:off x="2532427" y="1174558"/>
            <a:ext cx="2129791" cy="587022"/>
          </a:xfrm>
          <a:prstGeom prst="rect">
            <a:avLst/>
          </a:prstGeom>
        </p:spPr>
      </p:pic>
      <p:sp>
        <p:nvSpPr>
          <p:cNvPr id="3" name="Isosceles Triangle 2"/>
          <p:cNvSpPr/>
          <p:nvPr/>
        </p:nvSpPr>
        <p:spPr>
          <a:xfrm rot="5400000">
            <a:off x="2438179" y="1459356"/>
            <a:ext cx="66039" cy="99977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4" name="Isosceles Triangle 3"/>
          <p:cNvSpPr/>
          <p:nvPr/>
        </p:nvSpPr>
        <p:spPr>
          <a:xfrm rot="5400000">
            <a:off x="2438179" y="1561170"/>
            <a:ext cx="66039" cy="99977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5" name="TextBox 4"/>
          <p:cNvSpPr txBox="1"/>
          <p:nvPr/>
        </p:nvSpPr>
        <p:spPr>
          <a:xfrm>
            <a:off x="1254753" y="1329808"/>
            <a:ext cx="125867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 err="1"/>
              <a:t>hnRNP</a:t>
            </a:r>
            <a:r>
              <a:rPr lang="en-GB" sz="1156" dirty="0"/>
              <a:t> H (53 </a:t>
            </a:r>
            <a:r>
              <a:rPr lang="en-GB" sz="1156" dirty="0" err="1"/>
              <a:t>kDa</a:t>
            </a:r>
            <a:r>
              <a:rPr lang="en-GB" sz="1156" dirty="0"/>
              <a:t>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267486" y="1464904"/>
            <a:ext cx="1233030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 err="1"/>
              <a:t>hnRNP</a:t>
            </a:r>
            <a:r>
              <a:rPr lang="en-GB" sz="1156" dirty="0"/>
              <a:t> F (49 </a:t>
            </a:r>
            <a:r>
              <a:rPr lang="en-GB" sz="1156" dirty="0" err="1"/>
              <a:t>kDa</a:t>
            </a:r>
            <a:r>
              <a:rPr lang="en-GB" sz="1156" dirty="0"/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448037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706692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965876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224531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496449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755107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014288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272946" y="945108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684411" y="242821"/>
            <a:ext cx="750526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Unbound</a:t>
            </a:r>
          </a:p>
        </p:txBody>
      </p:sp>
      <p:sp>
        <p:nvSpPr>
          <p:cNvPr id="16" name="Right Bracket 15"/>
          <p:cNvSpPr/>
          <p:nvPr/>
        </p:nvSpPr>
        <p:spPr>
          <a:xfrm rot="16200000">
            <a:off x="3016931" y="122273"/>
            <a:ext cx="66039" cy="864025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17" name="TextBox 16"/>
          <p:cNvSpPr txBox="1"/>
          <p:nvPr/>
        </p:nvSpPr>
        <p:spPr>
          <a:xfrm>
            <a:off x="3823328" y="239476"/>
            <a:ext cx="57740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bound</a:t>
            </a:r>
          </a:p>
        </p:txBody>
      </p:sp>
      <p:sp>
        <p:nvSpPr>
          <p:cNvPr id="18" name="Right Bracket 17"/>
          <p:cNvSpPr/>
          <p:nvPr/>
        </p:nvSpPr>
        <p:spPr>
          <a:xfrm rot="16200000">
            <a:off x="4042837" y="118925"/>
            <a:ext cx="66039" cy="864025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19" name="TextBox 18"/>
          <p:cNvSpPr txBox="1"/>
          <p:nvPr/>
        </p:nvSpPr>
        <p:spPr>
          <a:xfrm>
            <a:off x="2465127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723784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982967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3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241623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4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13541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72197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31381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7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290036" y="1694175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8</a:t>
            </a: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71" t="32669" r="17882" b="60614"/>
          <a:stretch/>
        </p:blipFill>
        <p:spPr>
          <a:xfrm>
            <a:off x="2645839" y="3275815"/>
            <a:ext cx="1919563" cy="282428"/>
          </a:xfrm>
          <a:prstGeom prst="rect">
            <a:avLst/>
          </a:prstGeom>
        </p:spPr>
      </p:pic>
      <p:sp>
        <p:nvSpPr>
          <p:cNvPr id="28" name="Isosceles Triangle 27"/>
          <p:cNvSpPr/>
          <p:nvPr/>
        </p:nvSpPr>
        <p:spPr>
          <a:xfrm rot="5400000">
            <a:off x="2532283" y="3358154"/>
            <a:ext cx="66039" cy="99977"/>
          </a:xfrm>
          <a:prstGeom prst="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29" name="TextBox 28"/>
          <p:cNvSpPr txBox="1"/>
          <p:nvPr/>
        </p:nvSpPr>
        <p:spPr>
          <a:xfrm>
            <a:off x="1320223" y="3252539"/>
            <a:ext cx="1265090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 err="1"/>
              <a:t>hnRNP</a:t>
            </a:r>
            <a:r>
              <a:rPr lang="en-GB" sz="1156" dirty="0"/>
              <a:t> Q (70 </a:t>
            </a:r>
            <a:r>
              <a:rPr lang="en-GB" sz="1156" dirty="0" err="1"/>
              <a:t>kDa</a:t>
            </a:r>
            <a:r>
              <a:rPr lang="en-GB" sz="1156" dirty="0"/>
              <a:t>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496995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755650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014834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273489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545409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804064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063248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1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321903" y="3051400"/>
            <a:ext cx="35298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H2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717911" y="2334718"/>
            <a:ext cx="750526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Unbound</a:t>
            </a:r>
          </a:p>
        </p:txBody>
      </p:sp>
      <p:sp>
        <p:nvSpPr>
          <p:cNvPr id="39" name="Right Bracket 38"/>
          <p:cNvSpPr/>
          <p:nvPr/>
        </p:nvSpPr>
        <p:spPr>
          <a:xfrm rot="16200000">
            <a:off x="3034758" y="2214168"/>
            <a:ext cx="66039" cy="864025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40" name="TextBox 39"/>
          <p:cNvSpPr txBox="1"/>
          <p:nvPr/>
        </p:nvSpPr>
        <p:spPr>
          <a:xfrm>
            <a:off x="3814083" y="2331369"/>
            <a:ext cx="577402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bound</a:t>
            </a:r>
          </a:p>
        </p:txBody>
      </p:sp>
      <p:sp>
        <p:nvSpPr>
          <p:cNvPr id="41" name="Right Bracket 40"/>
          <p:cNvSpPr/>
          <p:nvPr/>
        </p:nvSpPr>
        <p:spPr>
          <a:xfrm rot="16200000">
            <a:off x="4060665" y="2210820"/>
            <a:ext cx="66039" cy="864025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42" name="TextBox 41"/>
          <p:cNvSpPr txBox="1"/>
          <p:nvPr/>
        </p:nvSpPr>
        <p:spPr>
          <a:xfrm>
            <a:off x="2617780" y="3534714"/>
            <a:ext cx="26000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9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801096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0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060279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1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318935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2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590854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3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818484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4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4070046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5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4290580" y="3534714"/>
            <a:ext cx="335348" cy="270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56" dirty="0"/>
              <a:t>16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31703" y="3946960"/>
            <a:ext cx="56776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5.  Protein detection after pulldown by RNA probes for rs1800547 and rs17651213.</a:t>
            </a:r>
            <a:r>
              <a:rPr lang="en-GB" sz="1200" dirty="0"/>
              <a:t>  </a:t>
            </a:r>
            <a:r>
              <a:rPr lang="en-GB" sz="1200" dirty="0" err="1"/>
              <a:t>hnRNP</a:t>
            </a:r>
            <a:r>
              <a:rPr lang="en-GB" sz="1200" dirty="0"/>
              <a:t> F and </a:t>
            </a:r>
            <a:r>
              <a:rPr lang="en-GB" sz="1200" dirty="0" err="1"/>
              <a:t>hnRNP</a:t>
            </a:r>
            <a:r>
              <a:rPr lang="en-GB" sz="1200" dirty="0"/>
              <a:t> Q are present in the RNA pull-down fractions using by Western blot analysis. Proteins in SK-N-F1 nuclear extract were pulled down by streptavidin magnetic beads using biotinylated-RNA probes containing rs1800547 and rs17651213 H1 and H2 SNP sequences. 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475182" y="561094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800</a:t>
            </a:r>
          </a:p>
          <a:p>
            <a:r>
              <a:rPr lang="en-GB" sz="1156" dirty="0"/>
              <a:t>-547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984186" y="561092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765</a:t>
            </a:r>
          </a:p>
          <a:p>
            <a:r>
              <a:rPr lang="en-GB" sz="1156" dirty="0"/>
              <a:t>-1213</a:t>
            </a:r>
          </a:p>
        </p:txBody>
      </p:sp>
      <p:sp>
        <p:nvSpPr>
          <p:cNvPr id="53" name="Right Bracket 52"/>
          <p:cNvSpPr/>
          <p:nvPr/>
        </p:nvSpPr>
        <p:spPr>
          <a:xfrm rot="16200000">
            <a:off x="2747906" y="772884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54" name="Right Bracket 53"/>
          <p:cNvSpPr/>
          <p:nvPr/>
        </p:nvSpPr>
        <p:spPr>
          <a:xfrm rot="16200000">
            <a:off x="3217373" y="772882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55" name="TextBox 54"/>
          <p:cNvSpPr txBox="1"/>
          <p:nvPr/>
        </p:nvSpPr>
        <p:spPr>
          <a:xfrm>
            <a:off x="3505288" y="534479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800</a:t>
            </a:r>
          </a:p>
          <a:p>
            <a:r>
              <a:rPr lang="en-GB" sz="1156" dirty="0"/>
              <a:t>-547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014292" y="534478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765</a:t>
            </a:r>
          </a:p>
          <a:p>
            <a:r>
              <a:rPr lang="en-GB" sz="1156" dirty="0"/>
              <a:t>-1213</a:t>
            </a:r>
          </a:p>
        </p:txBody>
      </p:sp>
      <p:sp>
        <p:nvSpPr>
          <p:cNvPr id="57" name="Right Bracket 56"/>
          <p:cNvSpPr/>
          <p:nvPr/>
        </p:nvSpPr>
        <p:spPr>
          <a:xfrm rot="16200000">
            <a:off x="3778012" y="746268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58" name="Right Bracket 57"/>
          <p:cNvSpPr/>
          <p:nvPr/>
        </p:nvSpPr>
        <p:spPr>
          <a:xfrm rot="16200000">
            <a:off x="4247479" y="746267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59" name="TextBox 58"/>
          <p:cNvSpPr txBox="1"/>
          <p:nvPr/>
        </p:nvSpPr>
        <p:spPr>
          <a:xfrm>
            <a:off x="2515312" y="2648134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800</a:t>
            </a:r>
          </a:p>
          <a:p>
            <a:r>
              <a:rPr lang="en-GB" sz="1156" dirty="0"/>
              <a:t>-547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024316" y="2648132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765</a:t>
            </a:r>
          </a:p>
          <a:p>
            <a:r>
              <a:rPr lang="en-GB" sz="1156" dirty="0"/>
              <a:t>-1213</a:t>
            </a:r>
          </a:p>
        </p:txBody>
      </p:sp>
      <p:sp>
        <p:nvSpPr>
          <p:cNvPr id="61" name="Right Bracket 60"/>
          <p:cNvSpPr/>
          <p:nvPr/>
        </p:nvSpPr>
        <p:spPr>
          <a:xfrm rot="16200000">
            <a:off x="2788036" y="2859922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62" name="Right Bracket 61"/>
          <p:cNvSpPr/>
          <p:nvPr/>
        </p:nvSpPr>
        <p:spPr>
          <a:xfrm rot="16200000">
            <a:off x="3257503" y="2859921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63" name="TextBox 62"/>
          <p:cNvSpPr txBox="1"/>
          <p:nvPr/>
        </p:nvSpPr>
        <p:spPr>
          <a:xfrm>
            <a:off x="3545418" y="2621518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800</a:t>
            </a:r>
          </a:p>
          <a:p>
            <a:r>
              <a:rPr lang="en-GB" sz="1156" dirty="0"/>
              <a:t>-547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054422" y="2621517"/>
            <a:ext cx="637354" cy="448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56" dirty="0"/>
              <a:t>rs1765</a:t>
            </a:r>
          </a:p>
          <a:p>
            <a:r>
              <a:rPr lang="en-GB" sz="1156" dirty="0"/>
              <a:t>-1213</a:t>
            </a:r>
          </a:p>
        </p:txBody>
      </p:sp>
      <p:sp>
        <p:nvSpPr>
          <p:cNvPr id="65" name="Right Bracket 64"/>
          <p:cNvSpPr/>
          <p:nvPr/>
        </p:nvSpPr>
        <p:spPr>
          <a:xfrm rot="16200000">
            <a:off x="3818142" y="2833307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  <p:sp>
        <p:nvSpPr>
          <p:cNvPr id="66" name="Right Bracket 65"/>
          <p:cNvSpPr/>
          <p:nvPr/>
        </p:nvSpPr>
        <p:spPr>
          <a:xfrm rot="16200000">
            <a:off x="4287609" y="2833306"/>
            <a:ext cx="54284" cy="418277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600"/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2" y="583991"/>
            <a:ext cx="5972933" cy="696974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79907" y="7732398"/>
            <a:ext cx="587402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6. Allele-specific qPCR for the detection of MAPT H1 and H2 transcripts in heterozygous cell lines. </a:t>
            </a:r>
            <a:r>
              <a:rPr lang="en-GB" sz="1200" dirty="0"/>
              <a:t>A) Primers and probes design for the allele-specific qPCR assay.  B) The quantitation of H1 and H2 transcripts were measured by VIC and FAM fluorescence signals, respectively, using qPCR. C) A standard curve was generated by mixing the H1 and H2 </a:t>
            </a:r>
            <a:r>
              <a:rPr lang="en-GB" sz="1200" dirty="0" err="1"/>
              <a:t>pMAPT</a:t>
            </a:r>
            <a:r>
              <a:rPr lang="en-GB" sz="1200" dirty="0"/>
              <a:t> vectors in the ratios 8:1, 4:1, 2:1, 1:1, 1:2, 1:4 and 1:8. The linear relationship between the delta Ct values and the log</a:t>
            </a:r>
            <a:r>
              <a:rPr lang="en-GB" sz="1200" baseline="-25000" dirty="0"/>
              <a:t>2</a:t>
            </a:r>
            <a:r>
              <a:rPr lang="en-GB" sz="1200" dirty="0"/>
              <a:t> ratios of H1:H2 transcripts allows for the quantification of H1:H2 transcripts by qPCR.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https://lh4.googleusercontent.com/wI2jFQJbVFdOtmre87JI3FcQsqMAraEza6MLmVUwHEbYqf1c_ar5fjcWRjHs_TWl2N6sZqxqxTr6HyUmOGl3xBMREM53q7XDciuibd5OoHLn64boU-RGE8XIpoVVhIfxy-C843Me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0" t="36661"/>
          <a:stretch/>
        </p:blipFill>
        <p:spPr bwMode="auto">
          <a:xfrm>
            <a:off x="836712" y="344487"/>
            <a:ext cx="4608512" cy="20482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https://lh3.googleusercontent.com/B7ada_o3Nxm_yvXwu_0DYrFap5LGgi071OeGEvE45sxEKj_wWMHMxq2TDLjDk2icgDhoI8CAYWerEb834YUMRDpD-M2duH9RLSiZduNtfyFMJpCOkIRFImy9l3uE4zO5NjpfBqcL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2648744"/>
            <a:ext cx="5400675" cy="5943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8620" y="8697416"/>
            <a:ext cx="64807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7 </a:t>
            </a:r>
            <a:r>
              <a:rPr lang="en-GB" sz="1200" dirty="0"/>
              <a:t>qPCR primer efficiencies as estimated from the standard curves generated from the serial dilution measurements. Efficiencies (E) are indicated above the line of best fit. </a:t>
            </a:r>
          </a:p>
        </p:txBody>
      </p:sp>
    </p:spTree>
    <p:extLst>
      <p:ext uri="{BB962C8B-B14F-4D97-AF65-F5344CB8AC3E}">
        <p14:creationId xmlns:p14="http://schemas.microsoft.com/office/powerpoint/2010/main" val="27824346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L:\Wade-Martins Group\Members\Brian\Thesis\Thesis Figures\knockdown efficiencies.tif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548"/>
          <a:stretch/>
        </p:blipFill>
        <p:spPr bwMode="auto">
          <a:xfrm>
            <a:off x="821429" y="1078189"/>
            <a:ext cx="5400675" cy="608647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821429" y="7336427"/>
            <a:ext cx="55317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8. siRNA knockdown of candidate splice factors identified by mass spectrometry. </a:t>
            </a:r>
            <a:r>
              <a:rPr lang="en-GB" sz="1200" dirty="0"/>
              <a:t> Efficiencies measured by qPCR in SK-N-F1 cells by different siRNAs against splice factors. </a:t>
            </a:r>
          </a:p>
        </p:txBody>
      </p:sp>
    </p:spTree>
    <p:extLst>
      <p:ext uri="{BB962C8B-B14F-4D97-AF65-F5344CB8AC3E}">
        <p14:creationId xmlns:p14="http://schemas.microsoft.com/office/powerpoint/2010/main" val="2417019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6</TotalTime>
  <Words>3137</Words>
  <Application>Microsoft Office PowerPoint</Application>
  <PresentationFormat>A4 Paper (210x297 mm)</PresentationFormat>
  <Paragraphs>359</Paragraphs>
  <Slides>2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8" baseType="lpstr">
      <vt:lpstr>Arial</vt:lpstr>
      <vt:lpstr>Calibri</vt:lpstr>
      <vt:lpstr>Segoe UI</vt:lpstr>
      <vt:lpstr>Time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</dc:creator>
  <cp:lastModifiedBy>Tara Caffrey</cp:lastModifiedBy>
  <cp:revision>49</cp:revision>
  <dcterms:created xsi:type="dcterms:W3CDTF">2017-05-23T14:13:53Z</dcterms:created>
  <dcterms:modified xsi:type="dcterms:W3CDTF">2017-09-24T22:23:20Z</dcterms:modified>
</cp:coreProperties>
</file>